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1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02" autoAdjust="0"/>
    <p:restoredTop sz="96691" autoAdjust="0"/>
  </p:normalViewPr>
  <p:slideViewPr>
    <p:cSldViewPr>
      <p:cViewPr>
        <p:scale>
          <a:sx n="120" d="100"/>
          <a:sy n="120" d="100"/>
        </p:scale>
        <p:origin x="-1638" y="351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t>27/11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t>27/11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5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6" y="9428584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36294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 descr="K:\## Molecular Oncology\Livio Trusolino\Tankyrase &amp; TNIK\Group\Tankyrase\1-Quaderni\Tankyrase - da settembre 2012\2015\REVOSIONE_MTOC\2-shTNKS 0 h_01_ProjMax001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7065" y="497505"/>
            <a:ext cx="1762125" cy="1584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K:\## Molecular Oncology\Livio Trusolino\Tankyrase &amp; TNIK\Group\Tankyrase\1-Quaderni\Tankyrase - da settembre 2012\2015\REVOSIONE_MTOC\4-shTNKS 1h_03_ProjMax001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7065" y="2117686"/>
            <a:ext cx="1762125" cy="1584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6" name="Group 5"/>
          <p:cNvGrpSpPr/>
          <p:nvPr/>
        </p:nvGrpSpPr>
        <p:grpSpPr>
          <a:xfrm>
            <a:off x="3377065" y="3737866"/>
            <a:ext cx="1762125" cy="1584325"/>
            <a:chOff x="3377065" y="3737866"/>
            <a:chExt cx="1762125" cy="1584325"/>
          </a:xfrm>
        </p:grpSpPr>
        <p:pic>
          <p:nvPicPr>
            <p:cNvPr id="1035" name="Picture 11" descr="K:\## Molecular Oncology\Livio Trusolino\Tankyrase &amp; TNIK\Group\Tankyrase\1-Quaderni\Tankyrase - da settembre 2012\2015\REVOSIONE_MTOC\6-shTNKS 4h_01_ProjMax001_ch00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7065" y="3737866"/>
              <a:ext cx="1762125" cy="15843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96" name="Straight Connector 95"/>
            <p:cNvCxnSpPr/>
            <p:nvPr/>
          </p:nvCxnSpPr>
          <p:spPr>
            <a:xfrm flipH="1" flipV="1">
              <a:off x="4466456" y="4929543"/>
              <a:ext cx="359938" cy="118888"/>
            </a:xfrm>
            <a:prstGeom prst="line">
              <a:avLst/>
            </a:prstGeom>
            <a:ln>
              <a:solidFill>
                <a:srgbClr val="FF0000"/>
              </a:solidFill>
              <a:headEnd type="stealth" w="sm" len="sm"/>
              <a:tailEnd type="non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Straight Connector 96"/>
            <p:cNvCxnSpPr/>
            <p:nvPr/>
          </p:nvCxnSpPr>
          <p:spPr>
            <a:xfrm flipH="1">
              <a:off x="4466069" y="4522885"/>
              <a:ext cx="133061" cy="401895"/>
            </a:xfrm>
            <a:prstGeom prst="line">
              <a:avLst/>
            </a:prstGeom>
            <a:ln w="6350">
              <a:solidFill>
                <a:schemeClr val="bg1"/>
              </a:solidFill>
              <a:prstDash val="solid"/>
              <a:headEnd type="stealth" w="sm" len="sm"/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1036" name="Picture 12" descr="K:\## Molecular Oncology\Livio Trusolino\Tankyrase &amp; TNIK\Group\Tankyrase\1-Quaderni\Tankyrase - da settembre 2012\2015\REVOSIONE_MTOC\5-scramble 4h_02_ProjMax001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147" y="3737866"/>
            <a:ext cx="1762125" cy="1584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 Box 26"/>
          <p:cNvSpPr txBox="1">
            <a:spLocks noChangeArrowheads="1"/>
          </p:cNvSpPr>
          <p:nvPr/>
        </p:nvSpPr>
        <p:spPr bwMode="auto">
          <a:xfrm>
            <a:off x="1054515" y="118057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26"/>
          <p:cNvSpPr txBox="1">
            <a:spLocks noChangeArrowheads="1"/>
          </p:cNvSpPr>
          <p:nvPr/>
        </p:nvSpPr>
        <p:spPr bwMode="auto">
          <a:xfrm>
            <a:off x="1054516" y="2836100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 Box 26"/>
          <p:cNvSpPr txBox="1">
            <a:spLocks noChangeArrowheads="1"/>
          </p:cNvSpPr>
          <p:nvPr/>
        </p:nvSpPr>
        <p:spPr bwMode="auto">
          <a:xfrm>
            <a:off x="1054516" y="4491624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Left Bracket 15"/>
          <p:cNvSpPr/>
          <p:nvPr/>
        </p:nvSpPr>
        <p:spPr>
          <a:xfrm>
            <a:off x="1269894" y="469900"/>
            <a:ext cx="108000" cy="4932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Text Box 26"/>
          <p:cNvSpPr txBox="1">
            <a:spLocks noChangeArrowheads="1"/>
          </p:cNvSpPr>
          <p:nvPr/>
        </p:nvSpPr>
        <p:spPr bwMode="auto">
          <a:xfrm rot="16200000">
            <a:off x="334448" y="2895936"/>
            <a:ext cx="16131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GF stimulation (h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 Box 26"/>
          <p:cNvSpPr txBox="1">
            <a:spLocks noChangeArrowheads="1"/>
          </p:cNvSpPr>
          <p:nvPr/>
        </p:nvSpPr>
        <p:spPr bwMode="auto">
          <a:xfrm>
            <a:off x="2096465" y="228599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b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26"/>
          <p:cNvSpPr txBox="1">
            <a:spLocks noChangeArrowheads="1"/>
          </p:cNvSpPr>
          <p:nvPr/>
        </p:nvSpPr>
        <p:spPr bwMode="auto">
          <a:xfrm>
            <a:off x="3637377" y="229716"/>
            <a:ext cx="121513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 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934540">
            <a:off x="2185958" y="670563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endParaRPr lang="it-IT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3366487" y="946486"/>
            <a:ext cx="1907718" cy="234092"/>
          </a:xfrm>
          <a:prstGeom prst="line">
            <a:avLst/>
          </a:prstGeom>
          <a:ln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329039" y="2671061"/>
            <a:ext cx="1810151" cy="238787"/>
          </a:xfrm>
          <a:prstGeom prst="line">
            <a:avLst/>
          </a:prstGeom>
          <a:ln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 rot="508559">
            <a:off x="4000944" y="2535539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endParaRPr lang="it-IT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 flipV="1">
            <a:off x="1485211" y="3988950"/>
            <a:ext cx="1844345" cy="1001435"/>
          </a:xfrm>
          <a:prstGeom prst="line">
            <a:avLst/>
          </a:prstGeom>
          <a:ln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 rot="19933370">
            <a:off x="2187488" y="4197542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endParaRPr lang="it-IT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/>
          <p:cNvCxnSpPr/>
          <p:nvPr/>
        </p:nvCxnSpPr>
        <p:spPr>
          <a:xfrm>
            <a:off x="3377065" y="4085957"/>
            <a:ext cx="1762125" cy="597013"/>
          </a:xfrm>
          <a:prstGeom prst="line">
            <a:avLst/>
          </a:prstGeom>
          <a:ln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 rot="1106726">
            <a:off x="4048968" y="4148005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endParaRPr lang="it-IT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1" name="Picture 7" descr="K:\## Molecular Oncology\Livio Trusolino\Tankyrase &amp; TNIK\Group\Tankyrase\1-Quaderni\Tankyrase - da settembre 2012\2015\REVOSIONE_MTOC\1-scramble 0h_01_ProjMax001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7147" y="497505"/>
            <a:ext cx="1762125" cy="1584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" name="Straight Connector 19"/>
          <p:cNvCxnSpPr/>
          <p:nvPr/>
        </p:nvCxnSpPr>
        <p:spPr>
          <a:xfrm>
            <a:off x="1545993" y="678076"/>
            <a:ext cx="1783279" cy="502502"/>
          </a:xfrm>
          <a:prstGeom prst="line">
            <a:avLst/>
          </a:prstGeom>
          <a:ln>
            <a:solidFill>
              <a:schemeClr val="bg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 flipH="1" flipV="1">
            <a:off x="2111717" y="1198393"/>
            <a:ext cx="231093" cy="167769"/>
          </a:xfrm>
          <a:prstGeom prst="line">
            <a:avLst/>
          </a:prstGeom>
          <a:ln>
            <a:solidFill>
              <a:srgbClr val="FF0000"/>
            </a:solidFill>
            <a:headEnd type="stealth" w="sm" len="sm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flipH="1">
            <a:off x="2106840" y="913600"/>
            <a:ext cx="90358" cy="278028"/>
          </a:xfrm>
          <a:prstGeom prst="line">
            <a:avLst/>
          </a:prstGeom>
          <a:ln w="6350">
            <a:solidFill>
              <a:schemeClr val="bg1"/>
            </a:solidFill>
            <a:prstDash val="solid"/>
            <a:headEnd type="stealth" w="sm" len="sm"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rot="365488">
            <a:off x="4000944" y="818986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endParaRPr lang="it-IT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1567147" y="2117686"/>
            <a:ext cx="1799340" cy="1584325"/>
            <a:chOff x="1567147" y="2117686"/>
            <a:chExt cx="1799340" cy="1584325"/>
          </a:xfrm>
        </p:grpSpPr>
        <p:pic>
          <p:nvPicPr>
            <p:cNvPr id="1034" name="Picture 10" descr="K:\## Molecular Oncology\Livio Trusolino\Tankyrase &amp; TNIK\Group\Tankyrase\1-Quaderni\Tankyrase - da settembre 2012\2015\REVOSIONE_MTOC\3-scramble 1h_04_ProjMax001_ch00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67147" y="2117686"/>
              <a:ext cx="1762125" cy="15843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8" name="Straight Connector 27"/>
            <p:cNvCxnSpPr>
              <a:stCxn id="1034" idx="1"/>
            </p:cNvCxnSpPr>
            <p:nvPr/>
          </p:nvCxnSpPr>
          <p:spPr>
            <a:xfrm flipV="1">
              <a:off x="1567147" y="2694551"/>
              <a:ext cx="1799340" cy="215298"/>
            </a:xfrm>
            <a:prstGeom prst="line">
              <a:avLst/>
            </a:prstGeom>
            <a:ln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 rot="21195977">
              <a:off x="2162245" y="2555645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9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ound</a:t>
              </a:r>
              <a:endParaRPr lang="it-IT" sz="9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5" name="Straight Connector 64"/>
          <p:cNvCxnSpPr/>
          <p:nvPr/>
        </p:nvCxnSpPr>
        <p:spPr>
          <a:xfrm flipH="1">
            <a:off x="2466817" y="2931018"/>
            <a:ext cx="115556" cy="394428"/>
          </a:xfrm>
          <a:prstGeom prst="line">
            <a:avLst/>
          </a:prstGeom>
          <a:ln>
            <a:solidFill>
              <a:srgbClr val="FF0000"/>
            </a:solidFill>
            <a:headEnd type="stealth" w="sm" len="sm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2428016" y="2868246"/>
            <a:ext cx="33979" cy="457200"/>
          </a:xfrm>
          <a:prstGeom prst="line">
            <a:avLst/>
          </a:prstGeom>
          <a:ln w="6350">
            <a:solidFill>
              <a:schemeClr val="bg1"/>
            </a:solidFill>
            <a:prstDash val="solid"/>
            <a:headEnd type="stealth" w="sm" len="sm"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rot="60000">
            <a:off x="2578853" y="4406198"/>
            <a:ext cx="323734" cy="569755"/>
          </a:xfrm>
          <a:prstGeom prst="line">
            <a:avLst/>
          </a:prstGeom>
          <a:ln w="6350">
            <a:solidFill>
              <a:schemeClr val="bg1"/>
            </a:solidFill>
            <a:prstDash val="solid"/>
            <a:headEnd type="stealth" w="sm" len="sm"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2698473" y="4607040"/>
            <a:ext cx="211688" cy="385984"/>
          </a:xfrm>
          <a:prstGeom prst="line">
            <a:avLst/>
          </a:prstGeom>
          <a:ln>
            <a:solidFill>
              <a:srgbClr val="FF0000"/>
            </a:solidFill>
            <a:headEnd type="stealth" w="sm" len="sm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329100" y="9567319"/>
            <a:ext cx="2449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it-IT" sz="100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it-IT" sz="1000" smtClean="0">
                <a:latin typeface="Arial" panose="020B0604020202020204" pitchFamily="34" charset="0"/>
                <a:cs typeface="Arial" panose="020B0604020202020204" pitchFamily="34" charset="0"/>
              </a:rPr>
              <a:t>16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03676" y="5776735"/>
            <a:ext cx="5850650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: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ntrosome relocation is perturbed by TNKS silencing</a:t>
            </a:r>
          </a:p>
          <a:p>
            <a:pPr algn="just"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focal images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ntrosome positioning in A549 cells transduced with either control (mock) or TNKS1/2-targeting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scratched with a pipette tip and stimulated with HGF (50 ng/ml) for 4 h. Immunofluorescence staining of centrosomes was performed with an anti-</a:t>
            </a:r>
            <a:r>
              <a:rPr lang="en-US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tubulin antibody. Shown here is a representative angl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form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y the nuclear-centrosome axis (r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row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a line perpendicular to the wound (white arrow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 Polarized centrosomes were defined as displaying </a:t>
            </a:r>
            <a:r>
              <a:rPr lang="en-US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 30°. Pictures refer to on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eriment out of two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rformed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cale bar, 7 </a:t>
            </a:r>
            <a:r>
              <a:rPr lang="en-US" sz="10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Connettore 1 55"/>
          <p:cNvCxnSpPr/>
          <p:nvPr/>
        </p:nvCxnSpPr>
        <p:spPr>
          <a:xfrm>
            <a:off x="1628800" y="2027675"/>
            <a:ext cx="14771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Arc 43"/>
          <p:cNvSpPr/>
          <p:nvPr/>
        </p:nvSpPr>
        <p:spPr>
          <a:xfrm rot="18856935">
            <a:off x="2417713" y="3151633"/>
            <a:ext cx="81179" cy="91440"/>
          </a:xfrm>
          <a:prstGeom prst="arc">
            <a:avLst>
              <a:gd name="adj1" fmla="val 19520413"/>
              <a:gd name="adj2" fmla="val 1636807"/>
            </a:avLst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" name="Arc 1"/>
          <p:cNvSpPr/>
          <p:nvPr/>
        </p:nvSpPr>
        <p:spPr>
          <a:xfrm>
            <a:off x="2068532" y="1149363"/>
            <a:ext cx="102416" cy="137899"/>
          </a:xfrm>
          <a:prstGeom prst="arc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60" name="Straight Connector 59"/>
          <p:cNvCxnSpPr/>
          <p:nvPr/>
        </p:nvCxnSpPr>
        <p:spPr>
          <a:xfrm>
            <a:off x="3564015" y="1263573"/>
            <a:ext cx="177361" cy="49027"/>
          </a:xfrm>
          <a:prstGeom prst="line">
            <a:avLst/>
          </a:prstGeom>
          <a:ln>
            <a:solidFill>
              <a:srgbClr val="FF0000"/>
            </a:solidFill>
            <a:headEnd type="stealth" w="sm" len="sm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flipH="1">
            <a:off x="3726016" y="992560"/>
            <a:ext cx="30719" cy="320040"/>
          </a:xfrm>
          <a:prstGeom prst="line">
            <a:avLst/>
          </a:prstGeom>
          <a:ln w="6350">
            <a:solidFill>
              <a:schemeClr val="bg1"/>
            </a:solidFill>
            <a:prstDash val="solid"/>
            <a:headEnd type="stealth" w="sm" len="sm"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Arc 47"/>
          <p:cNvSpPr/>
          <p:nvPr/>
        </p:nvSpPr>
        <p:spPr>
          <a:xfrm flipH="1">
            <a:off x="3698830" y="1263573"/>
            <a:ext cx="61079" cy="45719"/>
          </a:xfrm>
          <a:prstGeom prst="arc">
            <a:avLst>
              <a:gd name="adj1" fmla="val 16200000"/>
              <a:gd name="adj2" fmla="val 1360068"/>
            </a:avLst>
          </a:prstGeom>
          <a:ln w="63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Arc 4"/>
          <p:cNvSpPr/>
          <p:nvPr/>
        </p:nvSpPr>
        <p:spPr>
          <a:xfrm flipH="1">
            <a:off x="4919550" y="3313215"/>
            <a:ext cx="84624" cy="92080"/>
          </a:xfrm>
          <a:prstGeom prst="arc">
            <a:avLst>
              <a:gd name="adj1" fmla="val 16200000"/>
              <a:gd name="adj2" fmla="val 524999"/>
            </a:avLst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0" name="Arc 49"/>
          <p:cNvSpPr/>
          <p:nvPr/>
        </p:nvSpPr>
        <p:spPr>
          <a:xfrm>
            <a:off x="4442777" y="4857855"/>
            <a:ext cx="102416" cy="137899"/>
          </a:xfrm>
          <a:prstGeom prst="arc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1" name="TextBox 50"/>
          <p:cNvSpPr txBox="1"/>
          <p:nvPr/>
        </p:nvSpPr>
        <p:spPr>
          <a:xfrm>
            <a:off x="2087022" y="998233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111</a:t>
            </a:r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°</a:t>
            </a:r>
            <a:endParaRPr lang="it-IT" sz="900" dirty="0">
              <a:solidFill>
                <a:schemeClr val="bg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476588" y="130310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80</a:t>
            </a:r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°</a:t>
            </a:r>
            <a:endParaRPr lang="it-IT" sz="900" dirty="0">
              <a:solidFill>
                <a:schemeClr val="bg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023313" y="3077541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19</a:t>
            </a:r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°</a:t>
            </a:r>
            <a:endParaRPr lang="it-IT" sz="900" dirty="0">
              <a:solidFill>
                <a:schemeClr val="bg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737583" y="3405295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55</a:t>
            </a:r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°</a:t>
            </a:r>
            <a:endParaRPr lang="it-IT" sz="900" dirty="0">
              <a:solidFill>
                <a:schemeClr val="bg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725480" y="4933015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0</a:t>
            </a:r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°</a:t>
            </a:r>
            <a:endParaRPr lang="it-IT" sz="900" dirty="0">
              <a:solidFill>
                <a:schemeClr val="bg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463551" y="4735183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=85</a:t>
            </a:r>
            <a:r>
              <a:rPr lang="it-IT" sz="900" dirty="0" smtClean="0">
                <a:solidFill>
                  <a:schemeClr val="bg1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°</a:t>
            </a:r>
            <a:endParaRPr lang="it-IT" sz="900" dirty="0">
              <a:solidFill>
                <a:schemeClr val="bg1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>
            <a:off x="4698522" y="3235669"/>
            <a:ext cx="255745" cy="168738"/>
          </a:xfrm>
          <a:prstGeom prst="line">
            <a:avLst/>
          </a:prstGeom>
          <a:ln>
            <a:solidFill>
              <a:srgbClr val="FF0000"/>
            </a:solidFill>
            <a:headEnd type="stealth" w="sm" len="sm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>
            <a:off x="4955853" y="2902375"/>
            <a:ext cx="31158" cy="502920"/>
          </a:xfrm>
          <a:prstGeom prst="line">
            <a:avLst/>
          </a:prstGeom>
          <a:ln w="6350">
            <a:solidFill>
              <a:schemeClr val="bg1"/>
            </a:solidFill>
            <a:prstDash val="solid"/>
            <a:headEnd type="stealth" w="sm" len="sm"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 flipV="1">
            <a:off x="2101387" y="1291850"/>
            <a:ext cx="74788" cy="120444"/>
          </a:xfrm>
          <a:prstGeom prst="straightConnector1">
            <a:avLst/>
          </a:prstGeom>
          <a:ln w="12700">
            <a:solidFill>
              <a:srgbClr val="FFFF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3518487" y="1097259"/>
            <a:ext cx="74788" cy="118872"/>
          </a:xfrm>
          <a:prstGeom prst="straightConnector1">
            <a:avLst/>
          </a:prstGeom>
          <a:ln w="12700">
            <a:solidFill>
              <a:srgbClr val="FFFF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 flipH="1" flipV="1">
            <a:off x="2524596" y="3235670"/>
            <a:ext cx="73152" cy="118872"/>
          </a:xfrm>
          <a:prstGeom prst="straightConnector1">
            <a:avLst/>
          </a:prstGeom>
          <a:ln w="12700">
            <a:solidFill>
              <a:srgbClr val="FFFF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cxnSpLocks noChangeAspect="1"/>
          </p:cNvCxnSpPr>
          <p:nvPr/>
        </p:nvCxnSpPr>
        <p:spPr>
          <a:xfrm rot="3240000">
            <a:off x="4863788" y="3183095"/>
            <a:ext cx="73152" cy="118872"/>
          </a:xfrm>
          <a:prstGeom prst="straightConnector1">
            <a:avLst/>
          </a:prstGeom>
          <a:ln w="12700">
            <a:solidFill>
              <a:srgbClr val="FFFF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cxnSpLocks noChangeAspect="1"/>
          </p:cNvCxnSpPr>
          <p:nvPr/>
        </p:nvCxnSpPr>
        <p:spPr>
          <a:xfrm rot="3240000">
            <a:off x="2849277" y="4688060"/>
            <a:ext cx="73152" cy="118872"/>
          </a:xfrm>
          <a:prstGeom prst="straightConnector1">
            <a:avLst/>
          </a:prstGeom>
          <a:ln w="12700">
            <a:solidFill>
              <a:srgbClr val="FFFF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cxnSpLocks noChangeAspect="1"/>
          </p:cNvCxnSpPr>
          <p:nvPr/>
        </p:nvCxnSpPr>
        <p:spPr>
          <a:xfrm rot="12540000">
            <a:off x="4572603" y="5024261"/>
            <a:ext cx="73152" cy="118872"/>
          </a:xfrm>
          <a:prstGeom prst="straightConnector1">
            <a:avLst/>
          </a:prstGeom>
          <a:ln w="12700">
            <a:solidFill>
              <a:srgbClr val="FFFF00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 rot="876573">
            <a:off x="2237145" y="691652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endParaRPr lang="it-IT" sz="9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3223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175</TotalTime>
  <Words>158</Words>
  <Application>Microsoft Office PowerPoint</Application>
  <PresentationFormat>A4 Paper (210x297 mm)</PresentationFormat>
  <Paragraphs>2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52</cp:revision>
  <cp:lastPrinted>2015-05-16T17:22:13Z</cp:lastPrinted>
  <dcterms:created xsi:type="dcterms:W3CDTF">2006-08-16T00:00:00Z</dcterms:created>
  <dcterms:modified xsi:type="dcterms:W3CDTF">2015-11-27T18:27:22Z</dcterms:modified>
</cp:coreProperties>
</file>